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2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152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292"/>
    <p:restoredTop sz="94694"/>
  </p:normalViewPr>
  <p:slideViewPr>
    <p:cSldViewPr snapToGrid="0">
      <p:cViewPr>
        <p:scale>
          <a:sx n="140" d="100"/>
          <a:sy n="140" d="100"/>
        </p:scale>
        <p:origin x="-824" y="-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D17871-7C55-7949-A1EC-CC7A5AF13D85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064E23-20D5-AB4D-93B6-AA24E4DAE6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3875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942A9D-FF47-D027-F3CB-26F0EBFE00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DDFCFC5-E58F-81D5-19AF-9EAB521905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63CF92-03A5-EAE3-0032-F95888B8A8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72220F-2512-6601-D2EA-6B86A3993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99B91E-5140-9312-7AE4-3A132A251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2747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016045-FA59-0038-D977-04D8134398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9AFA8BD-6B5F-86C1-FBF7-C69D3E2B1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C89918-BD20-B681-93CA-90384E361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F4B0033-D83E-07A6-1884-5D03BE67C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7903251-CECE-93C7-20F6-8A56DFA7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603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D90C4C0-A51A-EBF2-3563-9E9BBB83AF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FAC6DFE-BF1D-1436-827E-D8E6BB948A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960B9F-7AD7-B023-1336-261C51937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5553B1-9FE7-253B-4A06-032CC0399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0E5885-AB15-386D-A298-E99CCCA73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261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EE312A-C27E-7EF8-8144-ABA1C66B63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A1EE223-A568-5F02-2636-0D5CEC4BBB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94BC5D-FC22-4F90-1C57-FD6733A66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48F8F1-FE7F-12CA-F74F-9F60C55AA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52AE87-DDCE-C24A-CC2C-4E254F713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161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CA5976-2226-9A41-2D7A-678AB89CD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AB87756-4471-49C8-7CCF-9ADEE5E8C6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88624C-4C7F-7E9D-7B5E-13DFCC386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3E87FC-A15A-4788-8ACE-7E81A87B4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FD0201-B96D-3CCD-84E0-DA889BFDF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292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C90B01-CD16-B7DF-F585-A8161FEAF4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0FD668E-84DB-AEFC-D163-EC61344A42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51DF1BD-BA8E-AE51-C295-6E66A970A2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B3270E-9C5C-92D3-C285-10CE9153A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996CDC0-E71A-4B89-65CE-073E2AEF4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6F4C993-DBAF-602D-9405-65E1C5D64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839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2042B2-0C49-AC9D-047A-BBE883BFEC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FBE626-7903-21C2-4BAA-0568C07A81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3E75AA9-611F-0BA5-F7CC-DCD631A8D1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31FCC54-AC81-B23F-2D0C-8536F2F31A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8D34B64-1858-D296-FE5C-FB2746B376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7750647-A761-0B2C-D9C8-9253FBF30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4DE0E64-CB44-4009-5C89-7B80B5B3A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38B15FC-69DE-9927-E733-C0AA142DC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536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CC4C51-5E4B-2EB6-98BF-B425A96349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F6E906B-746C-A875-88BD-8878669B6C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1CE6815-745E-11EE-684A-528D6F5C4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F62CF43-7BD9-8767-46EA-0BB855FC9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640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DFBD62B-2196-0CCE-4867-D14C4DE4D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4E124F7-5498-432B-F942-03F8965CE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48C0C32-FE9C-BE80-9496-54FDB17AC6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3723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480BEA-1786-8BC6-D5BC-F75515C4F2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77BEF94-7A15-4C23-C793-8A65D6D380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2DA2AE6-B1E6-C062-067B-0C91B26AD0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DABB4F-F6CF-D268-F7C0-02F0E05B2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5775DB1-F392-6A17-8F7C-D12E15D46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C098A54-479D-FB2F-A3C3-85781BC21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8823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D44AA6-4B8D-15AC-3384-52A6F8CC9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760C0B4-8608-BC6E-F92F-866E03D2C6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F698968-F470-BE44-B98F-E366FA7FE7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A75E459-2BEB-E4B3-87B3-6DDDC0C84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E88C043-9832-AAF7-66DD-7020E73FF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EBD323-E6E4-05DD-84FF-B9716518A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1934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E35D119-760C-E61E-297D-72BF98048E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36FECC-0932-6E0E-268C-FAA7561397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011CE4-41F4-5764-5397-0CCA07D9BE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B75AEF-2257-484C-9B23-81ADB1D8D56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46D44F-CFAA-1FD2-C3FA-EC75FC19F4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41A748-F35D-D04F-79CC-191C3A6460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265C1D-FA82-764C-B0F5-722256452E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6495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E692CB-2097-E8BA-0E45-E847D7548E0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図 21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2D547A9D-B578-03B4-826D-2741E23E0E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19754" y="1329741"/>
            <a:ext cx="4266000" cy="4266000"/>
          </a:xfrm>
          <a:prstGeom prst="rect">
            <a:avLst/>
          </a:prstGeom>
        </p:spPr>
      </p:pic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3A79CBB2-6ABE-F1C6-47B3-D0DFC2F82113}"/>
              </a:ext>
            </a:extLst>
          </p:cNvPr>
          <p:cNvCxnSpPr/>
          <p:nvPr/>
        </p:nvCxnSpPr>
        <p:spPr>
          <a:xfrm>
            <a:off x="7056718" y="1656798"/>
            <a:ext cx="262461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タイトル 1">
            <a:extLst>
              <a:ext uri="{FF2B5EF4-FFF2-40B4-BE49-F238E27FC236}">
                <a16:creationId xmlns:a16="http://schemas.microsoft.com/office/drawing/2014/main" id="{A23D4E41-411E-5304-F134-F29760FD80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19287" y="2978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Figure S6.</a:t>
            </a:r>
            <a:endParaRPr lang="ja-JP" altLang="en-US" sz="2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4AFC270-1A42-25F3-EE5E-3B7B1E4435E8}"/>
              </a:ext>
            </a:extLst>
          </p:cNvPr>
          <p:cNvSpPr txBox="1"/>
          <p:nvPr/>
        </p:nvSpPr>
        <p:spPr>
          <a:xfrm>
            <a:off x="1346200" y="105711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CFEEF58-D484-6634-49EB-2E16E4114C0A}"/>
              </a:ext>
            </a:extLst>
          </p:cNvPr>
          <p:cNvSpPr txBox="1"/>
          <p:nvPr/>
        </p:nvSpPr>
        <p:spPr>
          <a:xfrm>
            <a:off x="6110054" y="105711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" name="図 9" descr="グラフ, 箱ひげ図&#10;&#10;AI 生成コンテンツは誤りを含む可能性があります。">
            <a:extLst>
              <a:ext uri="{FF2B5EF4-FFF2-40B4-BE49-F238E27FC236}">
                <a16:creationId xmlns:a16="http://schemas.microsoft.com/office/drawing/2014/main" id="{FB71336B-2258-8116-B9A1-DDCC969767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3837" y="1426445"/>
            <a:ext cx="4267200" cy="4267200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737C6F3-81B5-ABA6-B2C9-7A4D30F406F1}"/>
              </a:ext>
            </a:extLst>
          </p:cNvPr>
          <p:cNvSpPr txBox="1"/>
          <p:nvPr/>
        </p:nvSpPr>
        <p:spPr>
          <a:xfrm>
            <a:off x="2841004" y="5354897"/>
            <a:ext cx="157286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R2-heterogeneity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2BC7360-6979-B85E-C06D-591BF42AC939}"/>
              </a:ext>
            </a:extLst>
          </p:cNvPr>
          <p:cNvSpPr txBox="1"/>
          <p:nvPr/>
        </p:nvSpPr>
        <p:spPr>
          <a:xfrm rot="16200000">
            <a:off x="263759" y="3290500"/>
            <a:ext cx="248497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LDN18.2-positive proportion (%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CF55005-7E2F-19CA-1B0C-55FBBF490CCD}"/>
              </a:ext>
            </a:extLst>
          </p:cNvPr>
          <p:cNvSpPr txBox="1"/>
          <p:nvPr/>
        </p:nvSpPr>
        <p:spPr>
          <a:xfrm>
            <a:off x="7674672" y="5077898"/>
            <a:ext cx="217880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R2-positive proportion (%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F7421DC-1AAF-8A6A-A5D3-AF614862912B}"/>
              </a:ext>
            </a:extLst>
          </p:cNvPr>
          <p:cNvSpPr txBox="1"/>
          <p:nvPr/>
        </p:nvSpPr>
        <p:spPr>
          <a:xfrm rot="16200000">
            <a:off x="5495009" y="3115211"/>
            <a:ext cx="24849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LDN18.2-positive proportion (%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D7DD02F-46B6-2180-7D07-D3F5A3694136}"/>
              </a:ext>
            </a:extLst>
          </p:cNvPr>
          <p:cNvSpPr txBox="1"/>
          <p:nvPr/>
        </p:nvSpPr>
        <p:spPr>
          <a:xfrm>
            <a:off x="7101955" y="4525458"/>
            <a:ext cx="13692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rho = -0.12, p = 0.45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A8C7CB7-414A-6975-DEE9-41265E0174AE}"/>
              </a:ext>
            </a:extLst>
          </p:cNvPr>
          <p:cNvSpPr txBox="1"/>
          <p:nvPr/>
        </p:nvSpPr>
        <p:spPr>
          <a:xfrm>
            <a:off x="3409119" y="1668157"/>
            <a:ext cx="6559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p = 0.16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DCA0618E-51E0-640F-DBE7-2D4212ABB349}"/>
              </a:ext>
            </a:extLst>
          </p:cNvPr>
          <p:cNvCxnSpPr/>
          <p:nvPr/>
        </p:nvCxnSpPr>
        <p:spPr>
          <a:xfrm>
            <a:off x="7044744" y="2577912"/>
            <a:ext cx="3438659" cy="0"/>
          </a:xfrm>
          <a:prstGeom prst="line">
            <a:avLst/>
          </a:prstGeom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E0E084B7-A7ED-C3E0-CA87-0B30188927FC}"/>
              </a:ext>
            </a:extLst>
          </p:cNvPr>
          <p:cNvCxnSpPr>
            <a:cxnSpLocks/>
          </p:cNvCxnSpPr>
          <p:nvPr/>
        </p:nvCxnSpPr>
        <p:spPr>
          <a:xfrm flipV="1">
            <a:off x="9681328" y="1741808"/>
            <a:ext cx="0" cy="3131999"/>
          </a:xfrm>
          <a:prstGeom prst="line">
            <a:avLst/>
          </a:prstGeom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F783AC2-3303-B498-1E28-A949BF34AD41}"/>
              </a:ext>
            </a:extLst>
          </p:cNvPr>
          <p:cNvSpPr txBox="1"/>
          <p:nvPr/>
        </p:nvSpPr>
        <p:spPr>
          <a:xfrm>
            <a:off x="9460138" y="4914000"/>
            <a:ext cx="2776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9</a:t>
            </a:r>
            <a:endParaRPr kumimoji="1" lang="ja-JP" altLang="en-US" sz="65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7418D62-F566-0BA4-7622-60399868DBCB}"/>
              </a:ext>
            </a:extLst>
          </p:cNvPr>
          <p:cNvSpPr txBox="1"/>
          <p:nvPr/>
        </p:nvSpPr>
        <p:spPr>
          <a:xfrm>
            <a:off x="6772666" y="2477884"/>
            <a:ext cx="277640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65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591CA5F-08CA-D3D8-E65A-CD4EE990522B}"/>
              </a:ext>
            </a:extLst>
          </p:cNvPr>
          <p:cNvSpPr txBox="1"/>
          <p:nvPr/>
        </p:nvSpPr>
        <p:spPr>
          <a:xfrm>
            <a:off x="9766473" y="1392404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E1526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</a:t>
            </a:r>
            <a:endParaRPr kumimoji="1" lang="ja-JP" altLang="en-US" sz="1000">
              <a:solidFill>
                <a:srgbClr val="E1526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790F95B-16A2-44E3-3B70-1F377F64DCDA}"/>
              </a:ext>
            </a:extLst>
          </p:cNvPr>
          <p:cNvSpPr txBox="1"/>
          <p:nvPr/>
        </p:nvSpPr>
        <p:spPr>
          <a:xfrm>
            <a:off x="8096352" y="1385777"/>
            <a:ext cx="545342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tero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C02FFBA7-1D90-BA2A-25B0-1BE7E96F6103}"/>
              </a:ext>
            </a:extLst>
          </p:cNvPr>
          <p:cNvCxnSpPr/>
          <p:nvPr/>
        </p:nvCxnSpPr>
        <p:spPr>
          <a:xfrm>
            <a:off x="9681328" y="1656798"/>
            <a:ext cx="673955" cy="0"/>
          </a:xfrm>
          <a:prstGeom prst="straightConnector1">
            <a:avLst/>
          </a:prstGeom>
          <a:ln>
            <a:solidFill>
              <a:srgbClr val="E1526B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E44B0A68-F33C-F02F-4CB8-5E5F745CE5AE}"/>
              </a:ext>
            </a:extLst>
          </p:cNvPr>
          <p:cNvCxnSpPr/>
          <p:nvPr/>
        </p:nvCxnSpPr>
        <p:spPr>
          <a:xfrm>
            <a:off x="10553743" y="2592898"/>
            <a:ext cx="0" cy="214296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BE9AD16-73FC-A021-9BFF-A470A994C4ED}"/>
              </a:ext>
            </a:extLst>
          </p:cNvPr>
          <p:cNvSpPr txBox="1"/>
          <p:nvPr/>
        </p:nvSpPr>
        <p:spPr>
          <a:xfrm rot="5400000">
            <a:off x="10370519" y="3436935"/>
            <a:ext cx="6126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LDN -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354325AE-B83B-8EE3-012D-B6D6805D6CF8}"/>
              </a:ext>
            </a:extLst>
          </p:cNvPr>
          <p:cNvCxnSpPr/>
          <p:nvPr/>
        </p:nvCxnSpPr>
        <p:spPr>
          <a:xfrm>
            <a:off x="10553742" y="1856935"/>
            <a:ext cx="0" cy="735963"/>
          </a:xfrm>
          <a:prstGeom prst="straightConnector1">
            <a:avLst/>
          </a:prstGeom>
          <a:ln>
            <a:solidFill>
              <a:srgbClr val="E1526B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09EBBE3-65BA-D30D-48D2-D688BBD29A26}"/>
              </a:ext>
            </a:extLst>
          </p:cNvPr>
          <p:cNvSpPr txBox="1"/>
          <p:nvPr/>
        </p:nvSpPr>
        <p:spPr>
          <a:xfrm rot="5400000">
            <a:off x="10354487" y="208327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E1526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DN +</a:t>
            </a:r>
            <a:endParaRPr kumimoji="1" lang="ja-JP" altLang="en-US" sz="1000">
              <a:solidFill>
                <a:srgbClr val="E1526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D3E6C3C-1324-F5D5-69C3-E9B267320956}"/>
              </a:ext>
            </a:extLst>
          </p:cNvPr>
          <p:cNvSpPr txBox="1"/>
          <p:nvPr/>
        </p:nvSpPr>
        <p:spPr>
          <a:xfrm>
            <a:off x="2692013" y="5114055"/>
            <a:ext cx="545342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tero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E3488D6-38D1-4D58-EF42-F43E055BA2E5}"/>
              </a:ext>
            </a:extLst>
          </p:cNvPr>
          <p:cNvSpPr txBox="1"/>
          <p:nvPr/>
        </p:nvSpPr>
        <p:spPr>
          <a:xfrm>
            <a:off x="4326346" y="5114054"/>
            <a:ext cx="50366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E1526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</a:t>
            </a:r>
            <a:endParaRPr kumimoji="1" lang="ja-JP" altLang="en-US" sz="1000">
              <a:solidFill>
                <a:srgbClr val="E1526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2C86F73F-07EE-858E-79E8-42BC64DF357E}"/>
              </a:ext>
            </a:extLst>
          </p:cNvPr>
          <p:cNvCxnSpPr>
            <a:cxnSpLocks/>
          </p:cNvCxnSpPr>
          <p:nvPr/>
        </p:nvCxnSpPr>
        <p:spPr>
          <a:xfrm flipH="1">
            <a:off x="2000250" y="3059039"/>
            <a:ext cx="278716" cy="0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FCB5EECA-6E86-21EB-FA07-6B7846206A1D}"/>
              </a:ext>
            </a:extLst>
          </p:cNvPr>
          <p:cNvSpPr txBox="1"/>
          <p:nvPr/>
        </p:nvSpPr>
        <p:spPr>
          <a:xfrm>
            <a:off x="1657447" y="294227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Hiragino Kaku Gothic Pro W3" panose="020B0300000000000000" pitchFamily="34" charset="-128"/>
                <a:cs typeface="Arial" panose="020B0604020202020204" pitchFamily="34" charset="0"/>
              </a:rPr>
              <a:t>65</a:t>
            </a:r>
            <a:endParaRPr kumimoji="1" lang="ja-JP" altLang="en-US" sz="900">
              <a:latin typeface="Arial" panose="020B0604020202020204" pitchFamily="34" charset="0"/>
              <a:ea typeface="Hiragino Kaku Gothic Pro W3" panose="020B0300000000000000" pitchFamily="34" charset="-128"/>
              <a:cs typeface="Arial" panose="020B0604020202020204" pitchFamily="34" charset="0"/>
            </a:endParaRP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390FC576-8BB5-C071-B66D-374B55F56FE9}"/>
              </a:ext>
            </a:extLst>
          </p:cNvPr>
          <p:cNvCxnSpPr/>
          <p:nvPr/>
        </p:nvCxnSpPr>
        <p:spPr>
          <a:xfrm flipH="1">
            <a:off x="2000250" y="3937000"/>
            <a:ext cx="1898650" cy="0"/>
          </a:xfrm>
          <a:prstGeom prst="line">
            <a:avLst/>
          </a:prstGeom>
          <a:ln>
            <a:solidFill>
              <a:srgbClr val="E1526B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42FCD73-CC88-9214-71BF-1F1404EE9625}"/>
              </a:ext>
            </a:extLst>
          </p:cNvPr>
          <p:cNvSpPr txBox="1"/>
          <p:nvPr/>
        </p:nvSpPr>
        <p:spPr>
          <a:xfrm>
            <a:off x="1657447" y="382158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solidFill>
                  <a:srgbClr val="E1526B"/>
                </a:solidFill>
                <a:latin typeface="Arial" panose="020B0604020202020204" pitchFamily="34" charset="0"/>
                <a:ea typeface="Hiragino Kaku Gothic Pro W3" panose="020B0300000000000000" pitchFamily="34" charset="-128"/>
                <a:cs typeface="Arial" panose="020B0604020202020204" pitchFamily="34" charset="0"/>
              </a:rPr>
              <a:t>35</a:t>
            </a:r>
            <a:endParaRPr kumimoji="1" lang="ja-JP" altLang="en-US" sz="900">
              <a:solidFill>
                <a:srgbClr val="E1526B"/>
              </a:solidFill>
              <a:latin typeface="Arial" panose="020B0604020202020204" pitchFamily="34" charset="0"/>
              <a:ea typeface="Hiragino Kaku Gothic Pro W3" panose="020B0300000000000000" pitchFamily="34" charset="-128"/>
              <a:cs typeface="Arial" panose="020B0604020202020204" pitchFamily="34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93F0B39D-10B2-484D-F59E-31AC8B70F526}"/>
              </a:ext>
            </a:extLst>
          </p:cNvPr>
          <p:cNvCxnSpPr/>
          <p:nvPr/>
        </p:nvCxnSpPr>
        <p:spPr>
          <a:xfrm>
            <a:off x="3898900" y="3937000"/>
            <a:ext cx="1322324" cy="0"/>
          </a:xfrm>
          <a:prstGeom prst="line">
            <a:avLst/>
          </a:prstGeom>
          <a:ln>
            <a:solidFill>
              <a:srgbClr val="E1526B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98475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38</Words>
  <Application>Microsoft Macintosh PowerPoint</Application>
  <PresentationFormat>ワイド画面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Figure S6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oichiro Yoshino</dc:creator>
  <cp:lastModifiedBy>Koichiro Yoshino</cp:lastModifiedBy>
  <cp:revision>4</cp:revision>
  <dcterms:created xsi:type="dcterms:W3CDTF">2026-02-17T05:49:32Z</dcterms:created>
  <dcterms:modified xsi:type="dcterms:W3CDTF">2026-02-24T00:56:49Z</dcterms:modified>
</cp:coreProperties>
</file>